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C32F24-C45F-4CD6-BBDE-58E1A986C14C}" v="3" dt="2026-03-30T16:43:50.2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2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C6179-A49C-D1A6-F411-B63ED27A3D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8C3CC3-FBA4-CC19-C974-707FC9FD41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8919E-5FD0-8FDC-724C-3D0701292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640E8B-F4EF-F338-1B5F-98BB7FD77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D7999-315B-1993-187F-924A20CC7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9483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2ADAF-DB3A-A999-BE4C-0D479DFE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661746-9976-D6D2-D7ED-A6E43F99FB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E5736D-70B9-1CF7-0F37-A071D7F16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2A990F-F512-9BDB-F943-E33AA8D5C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490A3A-29CC-CF1D-4FA6-2448944D7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168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05A6AF-A0B2-A575-2908-07A740E356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487EF3-6795-7D07-0D0B-AD49A8EB6A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F1AB03-BC5A-F36A-CFAF-8FAC6CEA7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A874E1-147C-72FA-0CE1-6B50E1C73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779A6-9AAF-C501-DCA2-EC780EC1F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2502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29FEF3-88CF-A962-0D4D-8C8B2EF47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3AA26F-658A-A3E8-3852-A121FB5922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3158C-F525-0B5A-CE77-F5BD0B093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A053F8-C74F-DE68-AF05-C65860B72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1BE201-6EB3-391A-D281-2A16E68B1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5743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8F61F-A6A8-CC92-9108-5EE90D1CC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12F0DD-9A05-5F8B-57B2-7B7C08729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269691-FA95-3E9E-D04B-C74A79783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B7F4B-63C3-49B7-7CAC-C9C2670A7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115B64-F298-BB11-D6B1-069A91557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5827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ADD16-48E1-FB8F-50F4-825D6071C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C70FEC-EBD0-A705-D2E6-B085AB918A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ADA3F1-B9F4-FC74-668F-3455F5E6B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F1664E-A037-D6E0-A8D5-6704CAACC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47C20-C44C-BEBB-A24E-4ADD6213D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4FA2F0-1376-D005-1439-2BAB53F80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016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78A321-8D07-B373-21E3-3B2C7DCBE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6C8431-BFC3-4F98-746D-F0DA2B2793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88856E-B4E5-27AE-4E58-21A542A652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CC437D-2A40-325B-4A3E-643CD51452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391379-E7D2-E7AB-DAB7-6C66DCA915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FB3D96-C16A-456D-2D55-69ABB23A7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A92A99-F5B5-790F-1569-2450B5199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992F50-EA63-A5A7-3DB6-A673C1901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730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3D50E-BFB3-8777-792B-276BB49E0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A9AFE4-595C-BF9B-C3A3-539CABEB9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1DC16D-5DD5-F953-9903-FC8A11938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B48E7B-8E1A-41F7-E470-134394C9F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812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4D029C-0920-A46B-08F9-3FBDBE8FB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50CD83-6079-50C3-FD7F-4254F733A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CF09C7-7EB0-0C5D-33AF-84AA9F3AA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88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8F7C0-EEAD-23B4-D79E-4727582FE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2DDD3D-5F40-2C54-21BB-E8B73EBA79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089A7E-8D29-FA00-73FE-6B3533FF7B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E40EA3-1382-459A-2A0D-E6E07B8FE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F29E7E-1361-FDD4-2B56-F14FE966F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6EC873-7433-AC3D-87A8-14EF69FDB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373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3B9D0-0CA9-D23C-84C4-E3A2C6609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02DFD1-93C2-40CC-1D4C-8164FC61C1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A49D2E-4BE3-B40E-CBD2-20DE6079CC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8C6661-F9A9-BE16-6765-6C8F83362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13BACA-6471-B779-6D0B-6FD100A45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D586A4-B6C9-EFDB-5889-751F3210E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5020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54D278-2FF1-5AD2-7977-FB420562A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3C1554-1C79-0C2B-A59C-E43D40CFB4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0617D-7111-0F44-90BD-024FC0F058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2A0554-EC56-4F85-AAAF-227828462C81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67A143-47DD-F100-5792-5A9DB06299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A4D77-3BB0-DE70-1F45-D5DFFE6E10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149003-C17D-42E2-A641-DB18C87105B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281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>
            <a:extLst>
              <a:ext uri="{FF2B5EF4-FFF2-40B4-BE49-F238E27FC236}">
                <a16:creationId xmlns:a16="http://schemas.microsoft.com/office/drawing/2014/main" id="{B38C4AF3-046F-474E-59E3-AC1C7F50512D}"/>
              </a:ext>
            </a:extLst>
          </p:cNvPr>
          <p:cNvSpPr/>
          <p:nvPr/>
        </p:nvSpPr>
        <p:spPr>
          <a:xfrm>
            <a:off x="10219409" y="344881"/>
            <a:ext cx="981075" cy="9239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8" name="f1_Xccb-film">
            <a:hlinkClick r:id="" action="ppaction://media"/>
            <a:extLst>
              <a:ext uri="{FF2B5EF4-FFF2-40B4-BE49-F238E27FC236}">
                <a16:creationId xmlns:a16="http://schemas.microsoft.com/office/drawing/2014/main" id="{C7A1BF0A-9C63-4BA3-6B1C-D6A93C9400A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044825" y="0"/>
            <a:ext cx="6858000" cy="6858000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AD2E32F-0891-4724-DED1-E5A15120328C}"/>
              </a:ext>
            </a:extLst>
          </p:cNvPr>
          <p:cNvCxnSpPr>
            <a:cxnSpLocks/>
          </p:cNvCxnSpPr>
          <p:nvPr/>
        </p:nvCxnSpPr>
        <p:spPr>
          <a:xfrm>
            <a:off x="7429500" y="4181475"/>
            <a:ext cx="0" cy="0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D128009-BB42-BE8C-E714-193615AE6109}"/>
              </a:ext>
            </a:extLst>
          </p:cNvPr>
          <p:cNvCxnSpPr>
            <a:cxnSpLocks/>
          </p:cNvCxnSpPr>
          <p:nvPr/>
        </p:nvCxnSpPr>
        <p:spPr>
          <a:xfrm flipV="1">
            <a:off x="3381375" y="3152775"/>
            <a:ext cx="66675" cy="66675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DBFBD59-2F6A-C5EF-88C6-9F1B02C8E079}"/>
              </a:ext>
            </a:extLst>
          </p:cNvPr>
          <p:cNvCxnSpPr>
            <a:cxnSpLocks/>
          </p:cNvCxnSpPr>
          <p:nvPr/>
        </p:nvCxnSpPr>
        <p:spPr>
          <a:xfrm flipH="1">
            <a:off x="3371850" y="2152650"/>
            <a:ext cx="57150" cy="100013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C00D4908-A97E-CE10-7EC4-CF82681C1EF8}"/>
              </a:ext>
            </a:extLst>
          </p:cNvPr>
          <p:cNvCxnSpPr>
            <a:cxnSpLocks/>
          </p:cNvCxnSpPr>
          <p:nvPr/>
        </p:nvCxnSpPr>
        <p:spPr>
          <a:xfrm flipH="1">
            <a:off x="4400550" y="4735830"/>
            <a:ext cx="57150" cy="100013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0E85FCB-76F4-9146-74CB-554E3660AE89}"/>
              </a:ext>
            </a:extLst>
          </p:cNvPr>
          <p:cNvCxnSpPr>
            <a:cxnSpLocks/>
          </p:cNvCxnSpPr>
          <p:nvPr/>
        </p:nvCxnSpPr>
        <p:spPr>
          <a:xfrm>
            <a:off x="3876675" y="5557838"/>
            <a:ext cx="60007" cy="6858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734296B-FDDA-BF37-4141-0A497E5373A4}"/>
              </a:ext>
            </a:extLst>
          </p:cNvPr>
          <p:cNvCxnSpPr>
            <a:cxnSpLocks/>
          </p:cNvCxnSpPr>
          <p:nvPr/>
        </p:nvCxnSpPr>
        <p:spPr>
          <a:xfrm flipV="1">
            <a:off x="7286625" y="4711541"/>
            <a:ext cx="63182" cy="74295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D560B1F-8E29-458B-39CA-02E4AABC51FC}"/>
              </a:ext>
            </a:extLst>
          </p:cNvPr>
          <p:cNvCxnSpPr>
            <a:cxnSpLocks/>
          </p:cNvCxnSpPr>
          <p:nvPr/>
        </p:nvCxnSpPr>
        <p:spPr>
          <a:xfrm flipH="1">
            <a:off x="7065645" y="3319463"/>
            <a:ext cx="97155" cy="0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3A4342D-BF22-98AF-C089-E87F9D257369}"/>
              </a:ext>
            </a:extLst>
          </p:cNvPr>
          <p:cNvCxnSpPr>
            <a:cxnSpLocks/>
          </p:cNvCxnSpPr>
          <p:nvPr/>
        </p:nvCxnSpPr>
        <p:spPr>
          <a:xfrm>
            <a:off x="4279900" y="5067300"/>
            <a:ext cx="50800" cy="54293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8BF18DC-A20B-0500-4CE5-EAE4D7256F8D}"/>
              </a:ext>
            </a:extLst>
          </p:cNvPr>
          <p:cNvCxnSpPr>
            <a:cxnSpLocks/>
          </p:cNvCxnSpPr>
          <p:nvPr/>
        </p:nvCxnSpPr>
        <p:spPr>
          <a:xfrm>
            <a:off x="10381303" y="694296"/>
            <a:ext cx="87917" cy="0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F7E1475-D6B6-54AD-2740-4B7BFBE26F69}"/>
              </a:ext>
            </a:extLst>
          </p:cNvPr>
          <p:cNvCxnSpPr>
            <a:cxnSpLocks/>
          </p:cNvCxnSpPr>
          <p:nvPr/>
        </p:nvCxnSpPr>
        <p:spPr>
          <a:xfrm>
            <a:off x="10368634" y="481358"/>
            <a:ext cx="100586" cy="0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48F34A04-69E1-2648-5CB8-1ED0619835A0}"/>
              </a:ext>
            </a:extLst>
          </p:cNvPr>
          <p:cNvCxnSpPr>
            <a:cxnSpLocks/>
          </p:cNvCxnSpPr>
          <p:nvPr/>
        </p:nvCxnSpPr>
        <p:spPr>
          <a:xfrm>
            <a:off x="10409213" y="1119732"/>
            <a:ext cx="60007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472A001-40B9-C22C-4265-4DA5DACB94BC}"/>
              </a:ext>
            </a:extLst>
          </p:cNvPr>
          <p:cNvCxnSpPr>
            <a:cxnSpLocks/>
          </p:cNvCxnSpPr>
          <p:nvPr/>
        </p:nvCxnSpPr>
        <p:spPr>
          <a:xfrm>
            <a:off x="10405809" y="907234"/>
            <a:ext cx="63411" cy="0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A81666DD-8C7F-C8CB-6104-70574D93F100}"/>
              </a:ext>
            </a:extLst>
          </p:cNvPr>
          <p:cNvSpPr txBox="1"/>
          <p:nvPr/>
        </p:nvSpPr>
        <p:spPr>
          <a:xfrm>
            <a:off x="10469221" y="383269"/>
            <a:ext cx="7312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solidFill>
                  <a:schemeClr val="bg1"/>
                </a:solidFill>
              </a:rPr>
              <a:t>Swell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Vanish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Round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Burs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1B3262E-5663-97DE-ADA2-B29764853833}"/>
              </a:ext>
            </a:extLst>
          </p:cNvPr>
          <p:cNvSpPr txBox="1"/>
          <p:nvPr/>
        </p:nvSpPr>
        <p:spPr>
          <a:xfrm>
            <a:off x="207390" y="311085"/>
            <a:ext cx="2271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-04-23 </a:t>
            </a:r>
            <a:r>
              <a:rPr lang="en-GB" dirty="0" err="1"/>
              <a:t>Xcc</a:t>
            </a:r>
            <a:r>
              <a:rPr lang="en-GB" dirty="0"/>
              <a:t>-WT f1</a:t>
            </a:r>
          </a:p>
        </p:txBody>
      </p:sp>
    </p:spTree>
    <p:extLst>
      <p:ext uri="{BB962C8B-B14F-4D97-AF65-F5344CB8AC3E}">
        <p14:creationId xmlns:p14="http://schemas.microsoft.com/office/powerpoint/2010/main" val="17227735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f3_Xccb-film">
            <a:hlinkClick r:id="" action="ppaction://media"/>
            <a:extLst>
              <a:ext uri="{FF2B5EF4-FFF2-40B4-BE49-F238E27FC236}">
                <a16:creationId xmlns:a16="http://schemas.microsoft.com/office/drawing/2014/main" id="{957A4921-C8F9-5A8B-606B-F4514D29FBB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319338" y="0"/>
            <a:ext cx="6858000" cy="6858000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B38C4AF3-046F-474E-59E3-AC1C7F50512D}"/>
              </a:ext>
            </a:extLst>
          </p:cNvPr>
          <p:cNvSpPr/>
          <p:nvPr/>
        </p:nvSpPr>
        <p:spPr>
          <a:xfrm>
            <a:off x="10219409" y="344881"/>
            <a:ext cx="981075" cy="9239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AD2E32F-0891-4724-DED1-E5A15120328C}"/>
              </a:ext>
            </a:extLst>
          </p:cNvPr>
          <p:cNvCxnSpPr>
            <a:cxnSpLocks/>
          </p:cNvCxnSpPr>
          <p:nvPr/>
        </p:nvCxnSpPr>
        <p:spPr>
          <a:xfrm flipH="1" flipV="1">
            <a:off x="8890634" y="2902266"/>
            <a:ext cx="77153" cy="7905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D128009-BB42-BE8C-E714-193615AE6109}"/>
              </a:ext>
            </a:extLst>
          </p:cNvPr>
          <p:cNvCxnSpPr>
            <a:cxnSpLocks/>
          </p:cNvCxnSpPr>
          <p:nvPr/>
        </p:nvCxnSpPr>
        <p:spPr>
          <a:xfrm flipH="1" flipV="1">
            <a:off x="5440680" y="2475097"/>
            <a:ext cx="59055" cy="104273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DBFBD59-2F6A-C5EF-88C6-9F1B02C8E079}"/>
              </a:ext>
            </a:extLst>
          </p:cNvPr>
          <p:cNvCxnSpPr>
            <a:cxnSpLocks/>
          </p:cNvCxnSpPr>
          <p:nvPr/>
        </p:nvCxnSpPr>
        <p:spPr>
          <a:xfrm flipV="1">
            <a:off x="3554746" y="2571525"/>
            <a:ext cx="0" cy="33112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0E85FCB-76F4-9146-74CB-554E3660AE89}"/>
              </a:ext>
            </a:extLst>
          </p:cNvPr>
          <p:cNvCxnSpPr>
            <a:cxnSpLocks/>
          </p:cNvCxnSpPr>
          <p:nvPr/>
        </p:nvCxnSpPr>
        <p:spPr>
          <a:xfrm>
            <a:off x="7753350" y="4367213"/>
            <a:ext cx="60007" cy="6858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734296B-FDDA-BF37-4141-0A497E5373A4}"/>
              </a:ext>
            </a:extLst>
          </p:cNvPr>
          <p:cNvCxnSpPr>
            <a:cxnSpLocks/>
          </p:cNvCxnSpPr>
          <p:nvPr/>
        </p:nvCxnSpPr>
        <p:spPr>
          <a:xfrm flipV="1">
            <a:off x="7639367" y="5328761"/>
            <a:ext cx="0" cy="81439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3A4342D-BF22-98AF-C089-E87F9D257369}"/>
              </a:ext>
            </a:extLst>
          </p:cNvPr>
          <p:cNvCxnSpPr>
            <a:cxnSpLocks/>
          </p:cNvCxnSpPr>
          <p:nvPr/>
        </p:nvCxnSpPr>
        <p:spPr>
          <a:xfrm flipH="1">
            <a:off x="3016250" y="2514598"/>
            <a:ext cx="41276" cy="66224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8BF18DC-A20B-0500-4CE5-EAE4D7256F8D}"/>
              </a:ext>
            </a:extLst>
          </p:cNvPr>
          <p:cNvCxnSpPr>
            <a:cxnSpLocks/>
          </p:cNvCxnSpPr>
          <p:nvPr/>
        </p:nvCxnSpPr>
        <p:spPr>
          <a:xfrm>
            <a:off x="10381303" y="694296"/>
            <a:ext cx="87917" cy="0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F7E1475-D6B6-54AD-2740-4B7BFBE26F69}"/>
              </a:ext>
            </a:extLst>
          </p:cNvPr>
          <p:cNvCxnSpPr>
            <a:cxnSpLocks/>
          </p:cNvCxnSpPr>
          <p:nvPr/>
        </p:nvCxnSpPr>
        <p:spPr>
          <a:xfrm>
            <a:off x="10368634" y="481358"/>
            <a:ext cx="100586" cy="0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48F34A04-69E1-2648-5CB8-1ED0619835A0}"/>
              </a:ext>
            </a:extLst>
          </p:cNvPr>
          <p:cNvCxnSpPr>
            <a:cxnSpLocks/>
          </p:cNvCxnSpPr>
          <p:nvPr/>
        </p:nvCxnSpPr>
        <p:spPr>
          <a:xfrm>
            <a:off x="10409213" y="1119732"/>
            <a:ext cx="60007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472A001-40B9-C22C-4265-4DA5DACB94BC}"/>
              </a:ext>
            </a:extLst>
          </p:cNvPr>
          <p:cNvCxnSpPr>
            <a:cxnSpLocks/>
          </p:cNvCxnSpPr>
          <p:nvPr/>
        </p:nvCxnSpPr>
        <p:spPr>
          <a:xfrm>
            <a:off x="10405809" y="907234"/>
            <a:ext cx="63411" cy="0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65015F83-ACB0-6F18-F311-8B535AB8D27F}"/>
              </a:ext>
            </a:extLst>
          </p:cNvPr>
          <p:cNvCxnSpPr>
            <a:cxnSpLocks/>
          </p:cNvCxnSpPr>
          <p:nvPr/>
        </p:nvCxnSpPr>
        <p:spPr>
          <a:xfrm flipH="1">
            <a:off x="2741930" y="4075428"/>
            <a:ext cx="41276" cy="66224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D7AB9174-522C-008C-2CC5-78DB85C10F31}"/>
              </a:ext>
            </a:extLst>
          </p:cNvPr>
          <p:cNvCxnSpPr>
            <a:cxnSpLocks/>
          </p:cNvCxnSpPr>
          <p:nvPr/>
        </p:nvCxnSpPr>
        <p:spPr>
          <a:xfrm>
            <a:off x="4197689" y="5857453"/>
            <a:ext cx="40936" cy="81387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47DD376-C348-CF33-B58F-B3B51A0102BC}"/>
              </a:ext>
            </a:extLst>
          </p:cNvPr>
          <p:cNvSpPr txBox="1"/>
          <p:nvPr/>
        </p:nvSpPr>
        <p:spPr>
          <a:xfrm>
            <a:off x="207390" y="311085"/>
            <a:ext cx="2271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-04-23 </a:t>
            </a:r>
            <a:r>
              <a:rPr lang="en-GB" dirty="0" err="1"/>
              <a:t>Xcc</a:t>
            </a:r>
            <a:r>
              <a:rPr lang="en-GB" dirty="0"/>
              <a:t>-WT f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E0D003-2807-7CEF-3192-1745C2A3E3EB}"/>
              </a:ext>
            </a:extLst>
          </p:cNvPr>
          <p:cNvSpPr txBox="1"/>
          <p:nvPr/>
        </p:nvSpPr>
        <p:spPr>
          <a:xfrm>
            <a:off x="10469221" y="383269"/>
            <a:ext cx="7312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solidFill>
                  <a:schemeClr val="bg1"/>
                </a:solidFill>
              </a:rPr>
              <a:t>Swell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Vanish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Round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Burst</a:t>
            </a:r>
          </a:p>
        </p:txBody>
      </p:sp>
    </p:spTree>
    <p:extLst>
      <p:ext uri="{BB962C8B-B14F-4D97-AF65-F5344CB8AC3E}">
        <p14:creationId xmlns:p14="http://schemas.microsoft.com/office/powerpoint/2010/main" val="25589568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>
            <a:extLst>
              <a:ext uri="{FF2B5EF4-FFF2-40B4-BE49-F238E27FC236}">
                <a16:creationId xmlns:a16="http://schemas.microsoft.com/office/drawing/2014/main" id="{B38C4AF3-046F-474E-59E3-AC1C7F50512D}"/>
              </a:ext>
            </a:extLst>
          </p:cNvPr>
          <p:cNvSpPr/>
          <p:nvPr/>
        </p:nvSpPr>
        <p:spPr>
          <a:xfrm>
            <a:off x="10219409" y="344881"/>
            <a:ext cx="981075" cy="9239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8BF18DC-A20B-0500-4CE5-EAE4D7256F8D}"/>
              </a:ext>
            </a:extLst>
          </p:cNvPr>
          <p:cNvCxnSpPr>
            <a:cxnSpLocks/>
          </p:cNvCxnSpPr>
          <p:nvPr/>
        </p:nvCxnSpPr>
        <p:spPr>
          <a:xfrm>
            <a:off x="10381303" y="694296"/>
            <a:ext cx="87917" cy="0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F7E1475-D6B6-54AD-2740-4B7BFBE26F69}"/>
              </a:ext>
            </a:extLst>
          </p:cNvPr>
          <p:cNvCxnSpPr>
            <a:cxnSpLocks/>
          </p:cNvCxnSpPr>
          <p:nvPr/>
        </p:nvCxnSpPr>
        <p:spPr>
          <a:xfrm>
            <a:off x="10368634" y="481358"/>
            <a:ext cx="100586" cy="0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48F34A04-69E1-2648-5CB8-1ED0619835A0}"/>
              </a:ext>
            </a:extLst>
          </p:cNvPr>
          <p:cNvCxnSpPr>
            <a:cxnSpLocks/>
          </p:cNvCxnSpPr>
          <p:nvPr/>
        </p:nvCxnSpPr>
        <p:spPr>
          <a:xfrm>
            <a:off x="10409213" y="1119732"/>
            <a:ext cx="60007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472A001-40B9-C22C-4265-4DA5DACB94BC}"/>
              </a:ext>
            </a:extLst>
          </p:cNvPr>
          <p:cNvCxnSpPr>
            <a:cxnSpLocks/>
          </p:cNvCxnSpPr>
          <p:nvPr/>
        </p:nvCxnSpPr>
        <p:spPr>
          <a:xfrm>
            <a:off x="10405809" y="907234"/>
            <a:ext cx="63411" cy="0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E597C0CD-7FD6-300D-7B95-624903AA65F7}"/>
              </a:ext>
            </a:extLst>
          </p:cNvPr>
          <p:cNvSpPr txBox="1"/>
          <p:nvPr/>
        </p:nvSpPr>
        <p:spPr>
          <a:xfrm>
            <a:off x="207390" y="311085"/>
            <a:ext cx="2271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-04-11 </a:t>
            </a:r>
            <a:r>
              <a:rPr lang="en-GB" dirty="0" err="1"/>
              <a:t>Ec</a:t>
            </a:r>
            <a:r>
              <a:rPr lang="en-GB" dirty="0"/>
              <a:t>-WT f1</a:t>
            </a:r>
          </a:p>
        </p:txBody>
      </p:sp>
      <p:pic>
        <p:nvPicPr>
          <p:cNvPr id="6" name="1field-W3110-film">
            <a:hlinkClick r:id="" action="ppaction://media"/>
            <a:extLst>
              <a:ext uri="{FF2B5EF4-FFF2-40B4-BE49-F238E27FC236}">
                <a16:creationId xmlns:a16="http://schemas.microsoft.com/office/drawing/2014/main" id="{29B959A0-8789-17FA-4A2B-EF1BCC5109D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665649" y="0"/>
            <a:ext cx="6858000" cy="6858000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CD7244F-6880-483A-4BFF-4248E871546A}"/>
              </a:ext>
            </a:extLst>
          </p:cNvPr>
          <p:cNvCxnSpPr>
            <a:cxnSpLocks/>
          </p:cNvCxnSpPr>
          <p:nvPr/>
        </p:nvCxnSpPr>
        <p:spPr>
          <a:xfrm flipH="1" flipV="1">
            <a:off x="5722620" y="973957"/>
            <a:ext cx="59055" cy="104273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5C3B134F-97FE-B493-9357-89F124792072}"/>
              </a:ext>
            </a:extLst>
          </p:cNvPr>
          <p:cNvCxnSpPr>
            <a:cxnSpLocks/>
          </p:cNvCxnSpPr>
          <p:nvPr/>
        </p:nvCxnSpPr>
        <p:spPr>
          <a:xfrm>
            <a:off x="7044706" y="1873117"/>
            <a:ext cx="0" cy="69983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FA3AD0FC-120D-82A3-24F8-3F3BCA657EEB}"/>
              </a:ext>
            </a:extLst>
          </p:cNvPr>
          <p:cNvCxnSpPr>
            <a:cxnSpLocks/>
          </p:cNvCxnSpPr>
          <p:nvPr/>
        </p:nvCxnSpPr>
        <p:spPr>
          <a:xfrm flipH="1">
            <a:off x="6616151" y="2890839"/>
            <a:ext cx="84685" cy="67643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B337373-E513-7C50-CBA1-1ED5FE03C514}"/>
              </a:ext>
            </a:extLst>
          </p:cNvPr>
          <p:cNvCxnSpPr>
            <a:cxnSpLocks/>
          </p:cNvCxnSpPr>
          <p:nvPr/>
        </p:nvCxnSpPr>
        <p:spPr>
          <a:xfrm flipH="1">
            <a:off x="6004560" y="4511040"/>
            <a:ext cx="11747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BA58083-9C00-9B6F-4889-2707B5C11273}"/>
              </a:ext>
            </a:extLst>
          </p:cNvPr>
          <p:cNvCxnSpPr>
            <a:cxnSpLocks/>
          </p:cNvCxnSpPr>
          <p:nvPr/>
        </p:nvCxnSpPr>
        <p:spPr>
          <a:xfrm flipH="1">
            <a:off x="7252970" y="189165"/>
            <a:ext cx="107950" cy="0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320CA495-CEEE-5D75-CC83-0ABDE7D7BF0B}"/>
              </a:ext>
            </a:extLst>
          </p:cNvPr>
          <p:cNvCxnSpPr>
            <a:cxnSpLocks/>
          </p:cNvCxnSpPr>
          <p:nvPr/>
        </p:nvCxnSpPr>
        <p:spPr>
          <a:xfrm>
            <a:off x="8138160" y="2301240"/>
            <a:ext cx="82550" cy="64952"/>
          </a:xfrm>
          <a:prstGeom prst="straightConnector1">
            <a:avLst/>
          </a:prstGeom>
          <a:ln w="381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4960693-3113-701C-7BA5-8711F0849D22}"/>
              </a:ext>
            </a:extLst>
          </p:cNvPr>
          <p:cNvCxnSpPr>
            <a:cxnSpLocks/>
          </p:cNvCxnSpPr>
          <p:nvPr/>
        </p:nvCxnSpPr>
        <p:spPr>
          <a:xfrm>
            <a:off x="5972175" y="2785110"/>
            <a:ext cx="0" cy="38176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D3E0532-489D-9568-9923-543A7038F5AA}"/>
              </a:ext>
            </a:extLst>
          </p:cNvPr>
          <p:cNvSpPr txBox="1"/>
          <p:nvPr/>
        </p:nvSpPr>
        <p:spPr>
          <a:xfrm>
            <a:off x="10469221" y="383269"/>
            <a:ext cx="7312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solidFill>
                  <a:schemeClr val="bg1"/>
                </a:solidFill>
              </a:rPr>
              <a:t>Swell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Vanish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Rounding</a:t>
            </a:r>
          </a:p>
          <a:p>
            <a:endParaRPr lang="en-GB" sz="700" dirty="0">
              <a:solidFill>
                <a:schemeClr val="bg1"/>
              </a:solidFill>
            </a:endParaRPr>
          </a:p>
          <a:p>
            <a:r>
              <a:rPr lang="en-GB" sz="700" dirty="0">
                <a:solidFill>
                  <a:schemeClr val="bg1"/>
                </a:solidFill>
              </a:rPr>
              <a:t>Burst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068385B-4E3B-9791-76EB-3F78FEE83107}"/>
              </a:ext>
            </a:extLst>
          </p:cNvPr>
          <p:cNvCxnSpPr>
            <a:cxnSpLocks/>
          </p:cNvCxnSpPr>
          <p:nvPr/>
        </p:nvCxnSpPr>
        <p:spPr>
          <a:xfrm flipH="1" flipV="1">
            <a:off x="8890634" y="2902266"/>
            <a:ext cx="77153" cy="79058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236762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50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21</Words>
  <Application>Microsoft Office PowerPoint</Application>
  <PresentationFormat>Grand écran</PresentationFormat>
  <Paragraphs>24</Paragraphs>
  <Slides>3</Slides>
  <Notes>0</Notes>
  <HiddenSlides>0</HiddenSlides>
  <MMClips>3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b Taillefer</dc:creator>
  <cp:lastModifiedBy>Alain SARNIGUET</cp:lastModifiedBy>
  <cp:revision>4</cp:revision>
  <dcterms:created xsi:type="dcterms:W3CDTF">2026-02-10T14:12:57Z</dcterms:created>
  <dcterms:modified xsi:type="dcterms:W3CDTF">2026-03-31T07:58:29Z</dcterms:modified>
</cp:coreProperties>
</file>